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141"/>
    <p:restoredTop sz="94660"/>
  </p:normalViewPr>
  <p:slideViewPr>
    <p:cSldViewPr snapToGrid="0">
      <p:cViewPr varScale="1">
        <p:scale>
          <a:sx n="177" d="100"/>
          <a:sy n="177" d="100"/>
        </p:scale>
        <p:origin x="117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AFF214-F64F-08DC-0DB8-F91AE37F727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E2EB187-5129-FC18-F476-6E3FB9EDE89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E58E44-340E-9914-DC40-DD24B05F4C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CBF4E3-A243-8446-82B5-8D6F36DF5C81}" type="datetimeFigureOut">
              <a:rPr lang="en-US" smtClean="0"/>
              <a:t>9/27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AF5280-EAC3-740B-4CA1-3A5CFEB89F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3BFE2D-81CC-2EF8-BD6F-5D43EDAFC9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9B27C-1979-E04A-A352-26DF289920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25380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DE574E-36F7-94D8-875C-C111CAD049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B4B83B5-88EE-3E31-2D28-167551A40D6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A47230-87CB-6F95-4DB7-3A3A7C7949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CBF4E3-A243-8446-82B5-8D6F36DF5C81}" type="datetimeFigureOut">
              <a:rPr lang="en-US" smtClean="0"/>
              <a:t>9/27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B53A9F-8477-3368-E4C8-1335DDA15D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2F1B04-7138-DEE8-8BAB-72A1F03911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9B27C-1979-E04A-A352-26DF289920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71464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5B1529D-D1BE-E0DA-4B97-35768256CC8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3611473-C8BA-A973-67F7-CC7A92AAEC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2AEE64-AD33-3CA3-D7B5-E9732C91D7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CBF4E3-A243-8446-82B5-8D6F36DF5C81}" type="datetimeFigureOut">
              <a:rPr lang="en-US" smtClean="0"/>
              <a:t>9/27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0BBF39-F48D-DD11-24B1-61CD6618F4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FF02F6-F405-51B1-2F89-414862D691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9B27C-1979-E04A-A352-26DF289920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7673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43F669-52A9-7135-7AE4-75E25CFDC8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0A067D0-E807-3A75-8455-D92CB272D08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3C509B-D350-02B7-DE9C-FA16F7C7C0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CBF4E3-A243-8446-82B5-8D6F36DF5C81}" type="datetimeFigureOut">
              <a:rPr lang="en-US" smtClean="0"/>
              <a:t>9/27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31A763-02D8-7E3C-8A73-DBBB1F7768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89D289-00AC-35F7-E056-8E88AA3BBE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9B27C-1979-E04A-A352-26DF289920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75249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9C4682-004E-08AC-3E79-9F80E9C924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8129096-DB58-A853-994F-976234345C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FE3427-8D8D-A35B-6461-3A04B445DE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CBF4E3-A243-8446-82B5-8D6F36DF5C81}" type="datetimeFigureOut">
              <a:rPr lang="en-US" smtClean="0"/>
              <a:t>9/27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C61104-006B-E26D-3749-CD4C8BEC5E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971ECE-831E-53A9-F815-3A0232994A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9B27C-1979-E04A-A352-26DF289920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40815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EDEDA1-52AC-39BF-9B26-C0B4C59968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A717B9F-DC8C-E8C6-05A4-92D80FB9AC9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0CE588A-6B14-F917-86F4-EB47F77E4F0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2D4E19A-9967-8C22-D6D9-6AF699232F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CBF4E3-A243-8446-82B5-8D6F36DF5C81}" type="datetimeFigureOut">
              <a:rPr lang="en-US" smtClean="0"/>
              <a:t>9/27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04F93EF-BF10-0402-B398-D23025077B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2B5DD19-3174-D68C-29A6-71E8E9AC78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9B27C-1979-E04A-A352-26DF289920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40598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91C8D3-0FA7-7372-1FA2-7BFEFA1DF0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0F50350-CBB2-95AD-079E-694BF1B723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A4980C7-0D67-0C68-7CF4-929D8189F9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91298D0-AEA7-EEF7-6192-5A7BDEFE578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7B46A3B-3B13-B8A3-555E-5A33171E567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1E80ECF-FACB-DD77-4A5B-6DA3D7F848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CBF4E3-A243-8446-82B5-8D6F36DF5C81}" type="datetimeFigureOut">
              <a:rPr lang="en-US" smtClean="0"/>
              <a:t>9/27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A4CF8DD-BDEA-A3E5-8308-A9BF13FDFE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789D38B-5300-5DFD-C150-C8B72E2838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9B27C-1979-E04A-A352-26DF289920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62303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F28123-D994-80C2-CDC2-E57ED344DC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F099CE6-B53A-9753-48FE-D4452E10B9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CBF4E3-A243-8446-82B5-8D6F36DF5C81}" type="datetimeFigureOut">
              <a:rPr lang="en-US" smtClean="0"/>
              <a:t>9/27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5A14556-F7DB-DC45-AAC2-44A56973F5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F22D149-3402-634D-D689-EA78BA8EFE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9B27C-1979-E04A-A352-26DF289920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90825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43F5296-3666-7556-E40D-9343069C21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CBF4E3-A243-8446-82B5-8D6F36DF5C81}" type="datetimeFigureOut">
              <a:rPr lang="en-US" smtClean="0"/>
              <a:t>9/27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334E6BD-51F7-7C6F-EA9F-E9D9F35C09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EFCC84E-17FB-9868-D3DB-6A96A1C2AA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9B27C-1979-E04A-A352-26DF289920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21924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815030-4A3C-506A-CA1E-FB1A4D0F71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CF52A34-571F-0574-C965-B74F3AA9305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1115874-0B09-E8FB-3081-C4FE62DB1E5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BFBD283-B2E7-DAD7-4F1B-A29EE07BB1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CBF4E3-A243-8446-82B5-8D6F36DF5C81}" type="datetimeFigureOut">
              <a:rPr lang="en-US" smtClean="0"/>
              <a:t>9/27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5386214-E81A-0A66-96EC-B6DBE811C7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482CCB2-4C2A-8194-48C5-F88B3C01E7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9B27C-1979-E04A-A352-26DF289920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15719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FF55E1-0D1F-D2F5-D3C9-77EC234501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86185F3-DA8B-B9C1-44D1-2316E1C2FCA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9BA6698-C28F-F643-C572-AFB7F73A4B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0E077DA-8724-72BC-1004-651252D452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CBF4E3-A243-8446-82B5-8D6F36DF5C81}" type="datetimeFigureOut">
              <a:rPr lang="en-US" smtClean="0"/>
              <a:t>9/27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E5E10FA-520B-A5A4-A051-907D47A1FE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7C50084-CB45-072B-0F52-C9EA131A89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9B27C-1979-E04A-A352-26DF289920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2511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F1FB367-849C-48E0-2141-8F0605CDD2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EA7CEDA-8B6D-2A1E-EA90-BF211157B0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347B43-801B-F7BF-2A64-B624C7C3CE5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9CBF4E3-A243-8446-82B5-8D6F36DF5C81}" type="datetimeFigureOut">
              <a:rPr lang="en-US" smtClean="0"/>
              <a:t>9/27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FFCB7F-55D1-1357-5E00-2CBC52E71DF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641359-6280-A5DA-C344-F22EDE786C4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ED9B27C-1979-E04A-A352-26DF289920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35980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87A2940F-9617-7641-68EA-DBF71B8C152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32671273"/>
              </p:ext>
            </p:extLst>
          </p:nvPr>
        </p:nvGraphicFramePr>
        <p:xfrm>
          <a:off x="2032000" y="719666"/>
          <a:ext cx="8128000" cy="4079240"/>
        </p:xfrm>
        <a:graphic>
          <a:graphicData uri="http://schemas.openxmlformats.org/drawingml/2006/table">
            <a:tbl>
              <a:tblPr firstRow="1" bandRow="1">
                <a:tableStyleId>{D7AC3CCA-C797-4891-BE02-D94E43425B78}</a:tableStyleId>
              </a:tblPr>
              <a:tblGrid>
                <a:gridCol w="833600">
                  <a:extLst>
                    <a:ext uri="{9D8B030D-6E8A-4147-A177-3AD203B41FA5}">
                      <a16:colId xmlns:a16="http://schemas.microsoft.com/office/drawing/2014/main" val="2757202232"/>
                    </a:ext>
                  </a:extLst>
                </a:gridCol>
                <a:gridCol w="2671200">
                  <a:extLst>
                    <a:ext uri="{9D8B030D-6E8A-4147-A177-3AD203B41FA5}">
                      <a16:colId xmlns:a16="http://schemas.microsoft.com/office/drawing/2014/main" val="624559808"/>
                    </a:ext>
                  </a:extLst>
                </a:gridCol>
                <a:gridCol w="2591200">
                  <a:extLst>
                    <a:ext uri="{9D8B030D-6E8A-4147-A177-3AD203B41FA5}">
                      <a16:colId xmlns:a16="http://schemas.microsoft.com/office/drawing/2014/main" val="471742671"/>
                    </a:ext>
                  </a:extLst>
                </a:gridCol>
                <a:gridCol w="2032000">
                  <a:extLst>
                    <a:ext uri="{9D8B030D-6E8A-4147-A177-3AD203B41FA5}">
                      <a16:colId xmlns:a16="http://schemas.microsoft.com/office/drawing/2014/main" val="3106162579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</a:t>
                      </a:r>
                      <a:endParaRPr lang="en-CA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CA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CA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ession Number</a:t>
                      </a:r>
                      <a:endParaRPr lang="en-CA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679609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D1</a:t>
                      </a:r>
                      <a:endParaRPr lang="en-CA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0" u="none" strike="noStrike" dirty="0">
                          <a:solidFill>
                            <a:srgbClr val="222222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GTGATCTCACTCTCAGGA</a:t>
                      </a:r>
                      <a:endParaRPr lang="en-CA" sz="1200" b="0" i="0" u="none" strike="noStrike" dirty="0">
                        <a:solidFill>
                          <a:srgbClr val="222222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0" u="none" strike="noStrike">
                          <a:solidFill>
                            <a:srgbClr val="222222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ACAGGGAATGTTTACTGC</a:t>
                      </a:r>
                      <a:endParaRPr lang="en-CA" sz="1200" b="0" i="0" u="none" strike="noStrike">
                        <a:solidFill>
                          <a:srgbClr val="222222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13671.3</a:t>
                      </a:r>
                      <a:endParaRPr lang="en-CA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1264492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D2</a:t>
                      </a:r>
                      <a:endParaRPr lang="en-CA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AATGGTGGGGGACATATT</a:t>
                      </a:r>
                      <a:endParaRPr lang="en-CA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TGGGTCCTGATTAGAGCA</a:t>
                      </a:r>
                      <a:endParaRPr lang="en-CA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11434.2</a:t>
                      </a:r>
                      <a:endParaRPr lang="en-CA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3889204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D3</a:t>
                      </a:r>
                      <a:endParaRPr lang="en-CA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CAGAAATCTTTTCACGC</a:t>
                      </a:r>
                      <a:endParaRPr lang="en-CA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CAGACTCAAAGACTAGGG</a:t>
                      </a:r>
                      <a:endParaRPr lang="en-CA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11435.3</a:t>
                      </a:r>
                      <a:endParaRPr lang="en-CA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2500752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</a:t>
                      </a:r>
                      <a:endParaRPr lang="en-CA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TTGACAGAGAGCGGATTC</a:t>
                      </a:r>
                      <a:endParaRPr lang="en-CA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TTGCCTTGGAGTATCTGG</a:t>
                      </a:r>
                      <a:endParaRPr lang="en-CA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9804.2</a:t>
                      </a:r>
                      <a:endParaRPr lang="en-CA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8855088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CTIN</a:t>
                      </a:r>
                      <a:endParaRPr lang="en-CA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0" u="none" strike="noStrike" dirty="0">
                          <a:solidFill>
                            <a:srgbClr val="24242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TCAAGATCATTGCTCCTCCT</a:t>
                      </a:r>
                      <a:endParaRPr lang="en-CA" sz="1200" b="0" i="0" u="none" strike="noStrike" dirty="0">
                        <a:solidFill>
                          <a:srgbClr val="242424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0" u="none" strike="noStrike" dirty="0">
                          <a:solidFill>
                            <a:srgbClr val="24242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AACAGTCCGCCTAGAAGC</a:t>
                      </a:r>
                      <a:endParaRPr lang="en-CA" sz="1200" b="0" i="0" u="none" strike="noStrike" dirty="0">
                        <a:solidFill>
                          <a:srgbClr val="242424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0" u="none" strike="noStrike">
                          <a:solidFill>
                            <a:srgbClr val="24242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7393.5</a:t>
                      </a:r>
                      <a:endParaRPr lang="en-CA" sz="1200" b="0" i="0" u="none" strike="noStrike">
                        <a:solidFill>
                          <a:srgbClr val="242424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0097887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PARy</a:t>
                      </a:r>
                      <a:endParaRPr lang="en-CA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0" u="none" strike="noStrike">
                          <a:solidFill>
                            <a:srgbClr val="24242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TGTTATGGGTGAAACTCT</a:t>
                      </a:r>
                      <a:endParaRPr lang="en-CA" sz="1200" b="0" i="0" u="none" strike="noStrike">
                        <a:solidFill>
                          <a:srgbClr val="242424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0" u="none" strike="noStrike" dirty="0">
                          <a:solidFill>
                            <a:srgbClr val="24242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ATGTCAAAGGAATGCGAG</a:t>
                      </a:r>
                      <a:endParaRPr lang="en-CA" sz="1200" b="0" i="0" u="none" strike="noStrike" dirty="0">
                        <a:solidFill>
                          <a:srgbClr val="242424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0" u="none" strike="noStrike">
                          <a:solidFill>
                            <a:srgbClr val="24242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062476.1</a:t>
                      </a:r>
                      <a:endParaRPr lang="en-CA" sz="1200" b="0" i="0" u="none" strike="noStrike">
                        <a:solidFill>
                          <a:srgbClr val="242424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08732700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R6A1</a:t>
                      </a:r>
                      <a:endParaRPr lang="en-CA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CATCCAGTAGGTCTGTGG</a:t>
                      </a:r>
                      <a:endParaRPr lang="en-CA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CACAGCATACCCATCTTC</a:t>
                      </a:r>
                      <a:endParaRPr lang="en-CA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F390896.1</a:t>
                      </a:r>
                      <a:endParaRPr lang="en-CA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8755361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PX</a:t>
                      </a:r>
                      <a:endParaRPr lang="en-CA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2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TCCACCGTGTATGCCTTC</a:t>
                      </a:r>
                      <a:endParaRPr lang="en-CA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GATCGTTCATCTCGGTGT</a:t>
                      </a:r>
                      <a:endParaRPr lang="en-CA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8160.6</a:t>
                      </a:r>
                      <a:endParaRPr lang="en-CA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54713645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D1</a:t>
                      </a:r>
                      <a:endParaRPr lang="en-CA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0" u="none" strike="noStrike">
                          <a:solidFill>
                            <a:srgbClr val="24242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AGAGTAGCTGAGCTTTGG</a:t>
                      </a:r>
                      <a:endParaRPr lang="en-CA" sz="1200" b="0" i="0" u="none" strike="noStrike">
                        <a:solidFill>
                          <a:srgbClr val="242424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0" u="none" strike="noStrike" dirty="0">
                          <a:solidFill>
                            <a:srgbClr val="24242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TGCATCATTAACACCCCG</a:t>
                      </a:r>
                      <a:endParaRPr lang="en-CA" sz="1200" b="0" i="0" u="none" strike="noStrike" dirty="0">
                        <a:solidFill>
                          <a:srgbClr val="242424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0" u="none" strike="noStrike" dirty="0">
                          <a:solidFill>
                            <a:srgbClr val="24242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H002082.2</a:t>
                      </a:r>
                      <a:endParaRPr lang="en-CA" sz="1200" b="0" i="0" u="none" strike="noStrike" dirty="0">
                        <a:solidFill>
                          <a:srgbClr val="242424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77660121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UT4</a:t>
                      </a:r>
                      <a:endParaRPr lang="en-CA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0" u="none" strike="noStrike">
                          <a:solidFill>
                            <a:srgbClr val="24242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TGGCATGATCTCTTCCTT</a:t>
                      </a:r>
                      <a:endParaRPr lang="en-CA" sz="1200" b="0" i="0" u="none" strike="noStrike">
                        <a:solidFill>
                          <a:srgbClr val="242424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0" u="none" strike="noStrike" dirty="0">
                          <a:solidFill>
                            <a:srgbClr val="24242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GATGTTAGCCCTGAGTA</a:t>
                      </a:r>
                      <a:endParaRPr lang="en-CA" sz="1200" b="0" i="0" u="none" strike="noStrike" dirty="0">
                        <a:solidFill>
                          <a:srgbClr val="242424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0" u="none" strike="noStrike" dirty="0">
                          <a:solidFill>
                            <a:srgbClr val="242424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1359114.1</a:t>
                      </a:r>
                      <a:endParaRPr lang="en-CA" sz="1200" b="0" i="0" u="none" strike="noStrike" dirty="0">
                        <a:solidFill>
                          <a:srgbClr val="242424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973910373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BF0A9DC4-48A9-BDFF-ECAE-4970E4F54CFB}"/>
              </a:ext>
            </a:extLst>
          </p:cNvPr>
          <p:cNvSpPr txBox="1"/>
          <p:nvPr/>
        </p:nvSpPr>
        <p:spPr>
          <a:xfrm>
            <a:off x="1996000" y="442667"/>
            <a:ext cx="3772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Primers</a:t>
            </a:r>
          </a:p>
        </p:txBody>
      </p:sp>
    </p:spTree>
    <p:extLst>
      <p:ext uri="{BB962C8B-B14F-4D97-AF65-F5344CB8AC3E}">
        <p14:creationId xmlns:p14="http://schemas.microsoft.com/office/powerpoint/2010/main" val="41053731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64</Words>
  <Application>Microsoft Macintosh PowerPoint</Application>
  <PresentationFormat>Widescreen</PresentationFormat>
  <Paragraphs>4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nnifer Thompson</dc:creator>
  <cp:lastModifiedBy>Jennifer Thompson</cp:lastModifiedBy>
  <cp:revision>1</cp:revision>
  <dcterms:created xsi:type="dcterms:W3CDTF">2024-09-28T03:00:37Z</dcterms:created>
  <dcterms:modified xsi:type="dcterms:W3CDTF">2024-09-28T03:04:24Z</dcterms:modified>
</cp:coreProperties>
</file>